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60" r:id="rId2"/>
  </p:sldIdLst>
  <p:sldSz cx="28800425" cy="2159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22" d="100"/>
          <a:sy n="22" d="100"/>
        </p:scale>
        <p:origin x="1891" y="2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0032" y="3534924"/>
            <a:ext cx="24480361" cy="7519835"/>
          </a:xfrm>
        </p:spPr>
        <p:txBody>
          <a:bodyPr anchor="b"/>
          <a:lstStyle>
            <a:lvl1pPr algn="ctr"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053" y="11344752"/>
            <a:ext cx="21600319" cy="5214884"/>
          </a:xfrm>
        </p:spPr>
        <p:txBody>
          <a:bodyPr/>
          <a:lstStyle>
            <a:lvl1pPr marL="0" indent="0" algn="ctr">
              <a:buNone/>
              <a:defRPr sz="7559"/>
            </a:lvl1pPr>
            <a:lvl2pPr marL="1439951" indent="0" algn="ctr">
              <a:buNone/>
              <a:defRPr sz="6299"/>
            </a:lvl2pPr>
            <a:lvl3pPr marL="2879903" indent="0" algn="ctr">
              <a:buNone/>
              <a:defRPr sz="5669"/>
            </a:lvl3pPr>
            <a:lvl4pPr marL="4319854" indent="0" algn="ctr">
              <a:buNone/>
              <a:defRPr sz="5039"/>
            </a:lvl4pPr>
            <a:lvl5pPr marL="5759806" indent="0" algn="ctr">
              <a:buNone/>
              <a:defRPr sz="5039"/>
            </a:lvl5pPr>
            <a:lvl6pPr marL="7199757" indent="0" algn="ctr">
              <a:buNone/>
              <a:defRPr sz="5039"/>
            </a:lvl6pPr>
            <a:lvl7pPr marL="8639708" indent="0" algn="ctr">
              <a:buNone/>
              <a:defRPr sz="5039"/>
            </a:lvl7pPr>
            <a:lvl8pPr marL="10079660" indent="0" algn="ctr">
              <a:buNone/>
              <a:defRPr sz="5039"/>
            </a:lvl8pPr>
            <a:lvl9pPr marL="11519611" indent="0" algn="ctr">
              <a:buNone/>
              <a:defRPr sz="5039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47268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01016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0306" y="1149975"/>
            <a:ext cx="6210092" cy="18304599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031" y="1149975"/>
            <a:ext cx="18270270" cy="18304599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95586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59230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030" y="5384888"/>
            <a:ext cx="24840367" cy="8984801"/>
          </a:xfrm>
        </p:spPr>
        <p:txBody>
          <a:bodyPr anchor="b"/>
          <a:lstStyle>
            <a:lvl1pPr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030" y="14454688"/>
            <a:ext cx="24840367" cy="4724895"/>
          </a:xfrm>
        </p:spPr>
        <p:txBody>
          <a:bodyPr/>
          <a:lstStyle>
            <a:lvl1pPr marL="0" indent="0">
              <a:buNone/>
              <a:defRPr sz="7559">
                <a:solidFill>
                  <a:schemeClr val="tx1">
                    <a:tint val="82000"/>
                  </a:schemeClr>
                </a:solidFill>
              </a:defRPr>
            </a:lvl1pPr>
            <a:lvl2pPr marL="1439951" indent="0">
              <a:buNone/>
              <a:defRPr sz="6299">
                <a:solidFill>
                  <a:schemeClr val="tx1">
                    <a:tint val="82000"/>
                  </a:schemeClr>
                </a:solidFill>
              </a:defRPr>
            </a:lvl2pPr>
            <a:lvl3pPr marL="2879903" indent="0">
              <a:buNone/>
              <a:defRPr sz="5669">
                <a:solidFill>
                  <a:schemeClr val="tx1">
                    <a:tint val="82000"/>
                  </a:schemeClr>
                </a:solidFill>
              </a:defRPr>
            </a:lvl3pPr>
            <a:lvl4pPr marL="4319854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4pPr>
            <a:lvl5pPr marL="5759806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5pPr>
            <a:lvl6pPr marL="7199757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6pPr>
            <a:lvl7pPr marL="8639708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7pPr>
            <a:lvl8pPr marL="10079660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8pPr>
            <a:lvl9pPr marL="11519611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6719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029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0215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67139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149979"/>
            <a:ext cx="24840367" cy="4174910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784" y="5294885"/>
            <a:ext cx="12183928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784" y="7889827"/>
            <a:ext cx="12183928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0217" y="5294885"/>
            <a:ext cx="12243932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0217" y="7889827"/>
            <a:ext cx="12243932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8461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58756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29555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3932" y="3109937"/>
            <a:ext cx="14580215" cy="15349662"/>
          </a:xfrm>
        </p:spPr>
        <p:txBody>
          <a:bodyPr/>
          <a:lstStyle>
            <a:lvl1pPr>
              <a:defRPr sz="10078"/>
            </a:lvl1pPr>
            <a:lvl2pPr>
              <a:defRPr sz="8819"/>
            </a:lvl2pPr>
            <a:lvl3pPr>
              <a:defRPr sz="7559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9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3932" y="3109937"/>
            <a:ext cx="14580215" cy="15349662"/>
          </a:xfrm>
        </p:spPr>
        <p:txBody>
          <a:bodyPr anchor="t"/>
          <a:lstStyle>
            <a:lvl1pPr marL="0" indent="0">
              <a:buNone/>
              <a:defRPr sz="10078"/>
            </a:lvl1pPr>
            <a:lvl2pPr marL="1439951" indent="0">
              <a:buNone/>
              <a:defRPr sz="8819"/>
            </a:lvl2pPr>
            <a:lvl3pPr marL="2879903" indent="0">
              <a:buNone/>
              <a:defRPr sz="7559"/>
            </a:lvl3pPr>
            <a:lvl4pPr marL="4319854" indent="0">
              <a:buNone/>
              <a:defRPr sz="6299"/>
            </a:lvl4pPr>
            <a:lvl5pPr marL="5759806" indent="0">
              <a:buNone/>
              <a:defRPr sz="6299"/>
            </a:lvl5pPr>
            <a:lvl6pPr marL="7199757" indent="0">
              <a:buNone/>
              <a:defRPr sz="6299"/>
            </a:lvl6pPr>
            <a:lvl7pPr marL="8639708" indent="0">
              <a:buNone/>
              <a:defRPr sz="6299"/>
            </a:lvl7pPr>
            <a:lvl8pPr marL="10079660" indent="0">
              <a:buNone/>
              <a:defRPr sz="6299"/>
            </a:lvl8pPr>
            <a:lvl9pPr marL="11519611" indent="0">
              <a:buNone/>
              <a:defRPr sz="6299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49807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029" y="1149979"/>
            <a:ext cx="24840367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029" y="5749874"/>
            <a:ext cx="24840367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029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0141" y="20019564"/>
            <a:ext cx="9720143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0300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4131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879903" rtl="0" eaLnBrk="1" latinLnBrk="0" hangingPunct="1">
        <a:lnSpc>
          <a:spcPct val="90000"/>
        </a:lnSpc>
        <a:spcBef>
          <a:spcPct val="0"/>
        </a:spcBef>
        <a:buNone/>
        <a:defRPr sz="13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19976" indent="-719976" algn="l" defTabSz="2879903" rtl="0" eaLnBrk="1" latinLnBrk="0" hangingPunct="1">
        <a:lnSpc>
          <a:spcPct val="90000"/>
        </a:lnSpc>
        <a:spcBef>
          <a:spcPts val="3150"/>
        </a:spcBef>
        <a:buFont typeface="Arial" panose="020B0604020202020204" pitchFamily="34" charset="0"/>
        <a:buChar char="•"/>
        <a:defRPr sz="8819" kern="1200">
          <a:solidFill>
            <a:schemeClr val="tx1"/>
          </a:solidFill>
          <a:latin typeface="+mn-lt"/>
          <a:ea typeface="+mn-ea"/>
          <a:cs typeface="+mn-cs"/>
        </a:defRPr>
      </a:lvl1pPr>
      <a:lvl2pPr marL="215992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7559" kern="1200">
          <a:solidFill>
            <a:schemeClr val="tx1"/>
          </a:solidFill>
          <a:latin typeface="+mn-lt"/>
          <a:ea typeface="+mn-ea"/>
          <a:cs typeface="+mn-cs"/>
        </a:defRPr>
      </a:lvl2pPr>
      <a:lvl3pPr marL="3599879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6299" kern="1200">
          <a:solidFill>
            <a:schemeClr val="tx1"/>
          </a:solidFill>
          <a:latin typeface="+mn-lt"/>
          <a:ea typeface="+mn-ea"/>
          <a:cs typeface="+mn-cs"/>
        </a:defRPr>
      </a:lvl3pPr>
      <a:lvl4pPr marL="5039830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6479781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919733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9359684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799636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223958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1pPr>
      <a:lvl2pPr marL="143995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879903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3pPr>
      <a:lvl4pPr marL="4319854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5759806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199757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8639708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07966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151961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2528E41-6D31-E193-20FD-38CC0518808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B7B51B74-8D06-9C05-265A-8CB0BB2AC6AD}"/>
              </a:ext>
            </a:extLst>
          </p:cNvPr>
          <p:cNvSpPr txBox="1"/>
          <p:nvPr/>
        </p:nvSpPr>
        <p:spPr>
          <a:xfrm>
            <a:off x="544512" y="13051065"/>
            <a:ext cx="27711399" cy="81454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32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2: CD19⁺ B cells from 67NR tumor-bearing mice suppress osteolytic and metastatic disease in immunocompetent BALB/c mice. (A)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Experimental scheme: BALB/c mice were orthotopically injected into the mammary fat pad with 1 x 10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5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etastatic 4T1 tumor cells and received adoptive transfer of CD19⁺ B cells isolated from the iliac BM of 67NR tumor-bearing BALB/c donors were freshly isolated and MACS sorted using magnetic beads. Disease parameters were assessed on day 28 post-tumor injection and B cell transference (T 4T1) means mice that received only 4T1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D3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 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 cells with sAg; (T 4T1 + B Nv) means mice that received both 4T1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D3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 and Naïve CD19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 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 cells with sAg and (T 4T1 + B 67NR) means mice that received both 4T1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D3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 and 67NR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 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D19</a:t>
            </a:r>
            <a:r>
              <a:rPr lang="en-US" sz="3200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 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 cells with sAg. Naive mice were used as experimental controls (Nv). </a:t>
            </a:r>
            <a:r>
              <a:rPr lang="en-US" sz="32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B)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RANKL production by draining LNs and BM cells was measured by ELISA following </a:t>
            </a:r>
            <a:r>
              <a:rPr lang="en-US" sz="32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x vivo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restimulation with 4T1 </a:t>
            </a:r>
            <a:r>
              <a:rPr lang="en-US" sz="32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Ag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sAg). </a:t>
            </a:r>
            <a:r>
              <a:rPr lang="en-US" sz="32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C)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Histomorphometric analysis of iliac bones was performed to evaluate trabecular bone volume, expressed as a percentage of total tissue volume. </a:t>
            </a:r>
            <a:r>
              <a:rPr lang="en-US" sz="32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D)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he maximum area of primary tumors was determined using digital caliper measures. Tumor growth was monitored longitudinally and is shown as mean tumor volume (mm³) per group over time. </a:t>
            </a:r>
            <a:r>
              <a:rPr lang="en-US" sz="32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E)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lonogenic metastatic assays were performed using cells isolated from LN and BM on day 28 post-tumor implantation. Data are expressed as mean ± SD of 5 mice per group and are representative of at least three independent experiments. Statistical significance was considered when </a:t>
            </a:r>
            <a:r>
              <a:rPr lang="en-US" sz="32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&lt; 0.05; *p &lt; 0.05, **p &lt; 0.01, ***p &lt; 0.001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endParaRPr lang="pt-BR" sz="3200" kern="100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8" name="Imagem 47">
            <a:extLst>
              <a:ext uri="{FF2B5EF4-FFF2-40B4-BE49-F238E27FC236}">
                <a16:creationId xmlns:a16="http://schemas.microsoft.com/office/drawing/2014/main" id="{F7A586DA-4C37-74A0-ACA5-B6C1CF8093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4512" y="403025"/>
            <a:ext cx="24469090" cy="12641623"/>
          </a:xfrm>
          <a:prstGeom prst="rect">
            <a:avLst/>
          </a:prstGeom>
        </p:spPr>
      </p:pic>
      <p:sp>
        <p:nvSpPr>
          <p:cNvPr id="49" name="CaixaDeTexto 48">
            <a:extLst>
              <a:ext uri="{FF2B5EF4-FFF2-40B4-BE49-F238E27FC236}">
                <a16:creationId xmlns:a16="http://schemas.microsoft.com/office/drawing/2014/main" id="{F212ED95-0829-42D6-4968-163243E449FF}"/>
              </a:ext>
            </a:extLst>
          </p:cNvPr>
          <p:cNvSpPr txBox="1"/>
          <p:nvPr/>
        </p:nvSpPr>
        <p:spPr>
          <a:xfrm>
            <a:off x="24357013" y="129908"/>
            <a:ext cx="4713288" cy="7587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32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2</a:t>
            </a:r>
            <a:endParaRPr lang="pt-BR" sz="3200" kern="100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33900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33</Words>
  <Application>Microsoft Office PowerPoint</Application>
  <PresentationFormat>Personalizar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 Monteiro</dc:creator>
  <cp:lastModifiedBy>Ana Monteiro</cp:lastModifiedBy>
  <cp:revision>2</cp:revision>
  <dcterms:created xsi:type="dcterms:W3CDTF">2025-11-20T17:53:58Z</dcterms:created>
  <dcterms:modified xsi:type="dcterms:W3CDTF">2025-11-20T17:56:08Z</dcterms:modified>
</cp:coreProperties>
</file>